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3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680"/>
  </p:normalViewPr>
  <p:slideViewPr>
    <p:cSldViewPr snapToGrid="0" snapToObjects="1" showGuides="1">
      <p:cViewPr varScale="1">
        <p:scale>
          <a:sx n="77" d="100"/>
          <a:sy n="77" d="100"/>
        </p:scale>
        <p:origin x="3096" y="200"/>
      </p:cViewPr>
      <p:guideLst>
        <p:guide orient="horz" pos="2880"/>
        <p:guide pos="23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803064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803696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480962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884265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864015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192163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888915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474054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881382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049780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501432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D30484-F1A2-F44B-91F1-BAA1853D1829}" type="datetimeFigureOut">
              <a:rPr lang="en-MX" smtClean="0"/>
              <a:t>30/04/22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FCDF47-AB6F-494A-A231-41ED38F9C36B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547983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2BA4EB51-CB48-B74A-BA19-24D1979F38AF}"/>
              </a:ext>
            </a:extLst>
          </p:cNvPr>
          <p:cNvSpPr/>
          <p:nvPr/>
        </p:nvSpPr>
        <p:spPr>
          <a:xfrm>
            <a:off x="1276062" y="2534654"/>
            <a:ext cx="1170584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n=19: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2827112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4452713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6121469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6144905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9133026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9646392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3682722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3854874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6547529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7589341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8031008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9008809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9724470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21801378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22920873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25505610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26043391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27016307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27544190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BC440A8-E652-FF48-B493-71AFAC828AEF}"/>
              </a:ext>
            </a:extLst>
          </p:cNvPr>
          <p:cNvSpPr/>
          <p:nvPr/>
        </p:nvSpPr>
        <p:spPr>
          <a:xfrm>
            <a:off x="4740481" y="4011982"/>
            <a:ext cx="115482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n=3: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0436603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9118625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20761322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F20CC93-629D-DB44-B18F-E83CFBD1354F}"/>
              </a:ext>
            </a:extLst>
          </p:cNvPr>
          <p:cNvSpPr/>
          <p:nvPr/>
        </p:nvSpPr>
        <p:spPr>
          <a:xfrm>
            <a:off x="3180618" y="3273318"/>
            <a:ext cx="112131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n=11: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3578041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4084157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6493994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7595943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2351433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2373771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3460409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4163776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4175438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7324128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22679120</a:t>
            </a: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6774D378-FACB-EA43-8803-C1DAABF7C07C}"/>
              </a:ext>
            </a:extLst>
          </p:cNvPr>
          <p:cNvSpPr>
            <a:spLocks noChangeAspect="1"/>
          </p:cNvSpPr>
          <p:nvPr/>
        </p:nvSpPr>
        <p:spPr>
          <a:xfrm>
            <a:off x="3111277" y="1194190"/>
            <a:ext cx="1260000" cy="1260000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X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B10B2C07-DABE-6345-826A-61D1E81A9098}"/>
              </a:ext>
            </a:extLst>
          </p:cNvPr>
          <p:cNvSpPr>
            <a:spLocks noChangeAspect="1"/>
          </p:cNvSpPr>
          <p:nvPr/>
        </p:nvSpPr>
        <p:spPr>
          <a:xfrm>
            <a:off x="425670" y="2170382"/>
            <a:ext cx="4209393" cy="4514197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X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1121325C-8912-0A41-8FB5-C08C8D71BFCC}"/>
              </a:ext>
            </a:extLst>
          </p:cNvPr>
          <p:cNvSpPr>
            <a:spLocks noChangeAspect="1"/>
          </p:cNvSpPr>
          <p:nvPr/>
        </p:nvSpPr>
        <p:spPr>
          <a:xfrm>
            <a:off x="2554014" y="2845671"/>
            <a:ext cx="3515710" cy="3163618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X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119C7D2-D4A3-0449-B115-9633E3C03864}"/>
              </a:ext>
            </a:extLst>
          </p:cNvPr>
          <p:cNvSpPr txBox="1"/>
          <p:nvPr/>
        </p:nvSpPr>
        <p:spPr>
          <a:xfrm>
            <a:off x="2137618" y="668646"/>
            <a:ext cx="32367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Differentially methylated CpG between</a:t>
            </a:r>
          </a:p>
          <a:p>
            <a:pPr algn="ct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atherosclerotic and normal aort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A9C07C6-A33C-ED46-A72E-DE07E19BD663}"/>
              </a:ext>
            </a:extLst>
          </p:cNvPr>
          <p:cNvSpPr txBox="1"/>
          <p:nvPr/>
        </p:nvSpPr>
        <p:spPr>
          <a:xfrm>
            <a:off x="271624" y="6562110"/>
            <a:ext cx="18277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CpG associated with</a:t>
            </a:r>
          </a:p>
          <a:p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chronological ag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9CD8041-9C96-6A41-8330-0ECD230CB3F5}"/>
              </a:ext>
            </a:extLst>
          </p:cNvPr>
          <p:cNvSpPr txBox="1"/>
          <p:nvPr/>
        </p:nvSpPr>
        <p:spPr>
          <a:xfrm>
            <a:off x="4444231" y="6003537"/>
            <a:ext cx="1875835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CpG associated with</a:t>
            </a:r>
          </a:p>
          <a:p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atheroma histological</a:t>
            </a:r>
          </a:p>
          <a:p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grade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5F2C3DD-5D3D-964D-BDF5-CDD4C249AC83}"/>
              </a:ext>
            </a:extLst>
          </p:cNvPr>
          <p:cNvSpPr/>
          <p:nvPr/>
        </p:nvSpPr>
        <p:spPr>
          <a:xfrm>
            <a:off x="3093816" y="1264551"/>
            <a:ext cx="131806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n=4: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1353448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01656216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14329157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g2280904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5B799DB-3AE5-6545-9A14-A80DB4DCD670}"/>
              </a:ext>
            </a:extLst>
          </p:cNvPr>
          <p:cNvSpPr txBox="1"/>
          <p:nvPr/>
        </p:nvSpPr>
        <p:spPr>
          <a:xfrm>
            <a:off x="604194" y="7548846"/>
            <a:ext cx="577573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MX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 Figure. Horvath clock CpG that were differentially methylated between atherosclerotic and healthy aortic portions, or associated </a:t>
            </a:r>
            <a:r>
              <a:rPr lang="es-ES" sz="12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ronological</a:t>
            </a:r>
            <a:r>
              <a:rPr lang="es-E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s-E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heroma</a:t>
            </a:r>
            <a:r>
              <a:rPr lang="es-E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ological</a:t>
            </a:r>
            <a:r>
              <a:rPr lang="es-E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rade</a:t>
            </a:r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MX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ifferential methylation was significant at genome-wide </a:t>
            </a:r>
            <a:r>
              <a:rPr lang="en-MX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vel (</a:t>
            </a:r>
            <a:r>
              <a:rPr lang="en-US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&lt;10</a:t>
            </a:r>
            <a:r>
              <a:rPr lang="en-US" sz="1200" baseline="30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Bonferroni correction; </a:t>
            </a:r>
            <a:r>
              <a:rPr lang="en-MX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e Table 1 for details). Other associations were significant at nominal significance level (p&lt;0.05; see S1 Table for details)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10A71E4-D558-A946-81F2-FBFD9D455BB7}"/>
              </a:ext>
            </a:extLst>
          </p:cNvPr>
          <p:cNvSpPr txBox="1"/>
          <p:nvPr/>
        </p:nvSpPr>
        <p:spPr>
          <a:xfrm>
            <a:off x="693683" y="236483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S1 Figure</a:t>
            </a:r>
          </a:p>
        </p:txBody>
      </p:sp>
    </p:spTree>
    <p:extLst>
      <p:ext uri="{BB962C8B-B14F-4D97-AF65-F5344CB8AC3E}">
        <p14:creationId xmlns:p14="http://schemas.microsoft.com/office/powerpoint/2010/main" val="3132925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4-3_vertical" id="{CB28F7D8-3726-7B45-9465-D23B4FEEE635}" vid="{DFDEAD01-9263-0D41-BAC1-E06D95E6E750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3</TotalTime>
  <Words>141</Words>
  <Application>Microsoft Macintosh PowerPoint</Application>
  <PresentationFormat>Letter Paper (8.5x11 in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ina</dc:creator>
  <cp:lastModifiedBy>szaina</cp:lastModifiedBy>
  <cp:revision>20</cp:revision>
  <dcterms:created xsi:type="dcterms:W3CDTF">2021-12-11T00:00:57Z</dcterms:created>
  <dcterms:modified xsi:type="dcterms:W3CDTF">2022-04-30T20:12:31Z</dcterms:modified>
</cp:coreProperties>
</file>